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61" r:id="rId3"/>
    <p:sldId id="263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E44482C-C861-4F69-9BFE-F76A9DA8EE51}" v="57" dt="2020-12-19T07:34:24.65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74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16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dmin\Dropbox\&#35542;&#25991;draft\&#29255;&#30000;anaerobic\201202Figur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dmin\Dropbox\&#35542;&#25991;draft\&#29255;&#30000;anaerobic\201202Figur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dmin\Dropbox\&#35542;&#25991;draft\&#29255;&#30000;anaerobic\201202Figur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dmin/Dropbox/&#35542;&#25991;draft/&#29255;&#30000;anaerobic/201211Figur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dmin/Dropbox/&#35542;&#25991;draft/&#29255;&#30000;anaerobic/201211Figur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dmin/Dropbox/&#35542;&#25991;draft/&#29255;&#30000;anaerobic/201211Figure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f953508f112dc111/Documents/&#39135;&#34907;/&#33521;&#35486;&#35542;&#25991;/Katada_Figs/201209Figure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f953508f112dc111/Documents/&#39135;&#34907;/&#33521;&#35486;&#35542;&#25991;/Katada_Figs/201209Figure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  <a:latin typeface="Century" panose="02040604050505020304" pitchFamily="18" charset="0"/>
                <a:ea typeface="ＭＳ 明朝" panose="02020609040205080304" pitchFamily="17" charset="-128"/>
              </a:rPr>
              <a:t>(a)</a:t>
            </a:r>
            <a:endParaRPr lang="ja-JP" altLang="en-US">
              <a:solidFill>
                <a:sysClr val="windowText" lastClr="000000"/>
              </a:solidFill>
              <a:latin typeface="Century" panose="02040604050505020304" pitchFamily="18" charset="0"/>
              <a:ea typeface="ＭＳ 明朝" panose="02020609040205080304" pitchFamily="17" charset="-128"/>
            </a:endParaRPr>
          </a:p>
        </c:rich>
      </c:tx>
      <c:layout>
        <c:manualLayout>
          <c:xMode val="edge"/>
          <c:yMode val="edge"/>
          <c:x val="7.2453121689550384E-2"/>
          <c:y val="2.24971992378789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ＭＳ 明朝" panose="02020609040205080304" pitchFamily="17" charset="-128"/>
              <a:ea typeface="ＭＳ 明朝" panose="02020609040205080304" pitchFamily="17" charset="-128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S1!$C$2</c:f>
              <c:strCache>
                <c:ptCount val="1"/>
                <c:pt idx="0">
                  <c:v>Spring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C$6:$C$8</c:f>
                <c:numCache>
                  <c:formatCode>General</c:formatCode>
                  <c:ptCount val="3"/>
                  <c:pt idx="0">
                    <c:v>0.45037219283088092</c:v>
                  </c:pt>
                  <c:pt idx="1">
                    <c:v>0.77610815223880492</c:v>
                  </c:pt>
                  <c:pt idx="2">
                    <c:v>0.81429914586429653</c:v>
                  </c:pt>
                </c:numCache>
              </c:numRef>
            </c:plus>
            <c:minus>
              <c:numRef>
                <c:f>FigS1!$C$6:$C$8</c:f>
                <c:numCache>
                  <c:formatCode>General</c:formatCode>
                  <c:ptCount val="3"/>
                  <c:pt idx="0">
                    <c:v>0.45037219283088092</c:v>
                  </c:pt>
                  <c:pt idx="1">
                    <c:v>0.77610815223880492</c:v>
                  </c:pt>
                  <c:pt idx="2">
                    <c:v>0.814299145864296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3:$B$5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C$3:$C$5</c:f>
              <c:numCache>
                <c:formatCode>General</c:formatCode>
                <c:ptCount val="3"/>
                <c:pt idx="0">
                  <c:v>1.9452982507218475</c:v>
                </c:pt>
                <c:pt idx="1">
                  <c:v>2.5082668719805294</c:v>
                </c:pt>
                <c:pt idx="2">
                  <c:v>1.75360179419498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1BC-A74B-A588-4AC4208E6C72}"/>
            </c:ext>
          </c:extLst>
        </c:ser>
        <c:ser>
          <c:idx val="1"/>
          <c:order val="1"/>
          <c:tx>
            <c:strRef>
              <c:f>FigS1!$D$2</c:f>
              <c:strCache>
                <c:ptCount val="1"/>
                <c:pt idx="0">
                  <c:v>Summer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D$6:$D$8</c:f>
                <c:numCache>
                  <c:formatCode>General</c:formatCode>
                  <c:ptCount val="3"/>
                  <c:pt idx="0">
                    <c:v>1.2195841295120609</c:v>
                  </c:pt>
                  <c:pt idx="1">
                    <c:v>1.7727059054971752</c:v>
                  </c:pt>
                  <c:pt idx="2">
                    <c:v>1.1248667464579647</c:v>
                  </c:pt>
                </c:numCache>
              </c:numRef>
            </c:plus>
            <c:minus>
              <c:numRef>
                <c:f>FigS1!$D$6:$D$8</c:f>
                <c:numCache>
                  <c:formatCode>General</c:formatCode>
                  <c:ptCount val="3"/>
                  <c:pt idx="0">
                    <c:v>1.2195841295120609</c:v>
                  </c:pt>
                  <c:pt idx="1">
                    <c:v>1.7727059054971752</c:v>
                  </c:pt>
                  <c:pt idx="2">
                    <c:v>1.12486674645796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3:$B$5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D$3:$D$5</c:f>
              <c:numCache>
                <c:formatCode>General</c:formatCode>
                <c:ptCount val="3"/>
                <c:pt idx="0">
                  <c:v>0.49841825434892528</c:v>
                </c:pt>
                <c:pt idx="1">
                  <c:v>1.2203418593396234</c:v>
                </c:pt>
                <c:pt idx="2">
                  <c:v>0.463864262426454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1BC-A74B-A588-4AC4208E6C72}"/>
            </c:ext>
          </c:extLst>
        </c:ser>
        <c:ser>
          <c:idx val="2"/>
          <c:order val="2"/>
          <c:tx>
            <c:strRef>
              <c:f>FigS1!$E$2</c:f>
              <c:strCache>
                <c:ptCount val="1"/>
                <c:pt idx="0">
                  <c:v>Autumn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E$6:$E$8</c:f>
                <c:numCache>
                  <c:formatCode>General</c:formatCode>
                  <c:ptCount val="3"/>
                  <c:pt idx="0">
                    <c:v>0.91301938014680273</c:v>
                  </c:pt>
                  <c:pt idx="1">
                    <c:v>0.72202747876613738</c:v>
                  </c:pt>
                  <c:pt idx="2">
                    <c:v>0.8394402065589478</c:v>
                  </c:pt>
                </c:numCache>
              </c:numRef>
            </c:plus>
            <c:minus>
              <c:numRef>
                <c:f>FigS1!$E$6:$E$8</c:f>
                <c:numCache>
                  <c:formatCode>General</c:formatCode>
                  <c:ptCount val="3"/>
                  <c:pt idx="0">
                    <c:v>0.91301938014680273</c:v>
                  </c:pt>
                  <c:pt idx="1">
                    <c:v>0.72202747876613738</c:v>
                  </c:pt>
                  <c:pt idx="2">
                    <c:v>0.83944020655894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3:$B$5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E$3:$E$5</c:f>
              <c:numCache>
                <c:formatCode>General</c:formatCode>
                <c:ptCount val="3"/>
                <c:pt idx="0">
                  <c:v>1.9719786728176647</c:v>
                </c:pt>
                <c:pt idx="1">
                  <c:v>2.4352235383340242</c:v>
                </c:pt>
                <c:pt idx="2">
                  <c:v>1.95190939250827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1BC-A74B-A588-4AC4208E6C72}"/>
            </c:ext>
          </c:extLst>
        </c:ser>
        <c:ser>
          <c:idx val="3"/>
          <c:order val="3"/>
          <c:tx>
            <c:strRef>
              <c:f>FigS1!$F$2</c:f>
              <c:strCache>
                <c:ptCount val="1"/>
                <c:pt idx="0">
                  <c:v>Winter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F$6:$F$8</c:f>
                <c:numCache>
                  <c:formatCode>General</c:formatCode>
                  <c:ptCount val="3"/>
                  <c:pt idx="0">
                    <c:v>0.98188378251861319</c:v>
                  </c:pt>
                  <c:pt idx="1">
                    <c:v>0.78004393244442816</c:v>
                  </c:pt>
                  <c:pt idx="2">
                    <c:v>1.0644071801605948</c:v>
                  </c:pt>
                </c:numCache>
              </c:numRef>
            </c:plus>
            <c:minus>
              <c:numRef>
                <c:f>FigS1!$F$6:$F$8</c:f>
                <c:numCache>
                  <c:formatCode>General</c:formatCode>
                  <c:ptCount val="3"/>
                  <c:pt idx="0">
                    <c:v>0.98188378251861319</c:v>
                  </c:pt>
                  <c:pt idx="1">
                    <c:v>0.78004393244442816</c:v>
                  </c:pt>
                  <c:pt idx="2">
                    <c:v>1.06440718016059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3:$B$5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F$3:$F$5</c:f>
              <c:numCache>
                <c:formatCode>General</c:formatCode>
                <c:ptCount val="3"/>
                <c:pt idx="0">
                  <c:v>1.5933232118422338</c:v>
                </c:pt>
                <c:pt idx="1">
                  <c:v>2.0112281959960763</c:v>
                </c:pt>
                <c:pt idx="2">
                  <c:v>0.446431881221051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1BC-A74B-A588-4AC4208E6C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6925280"/>
        <c:axId val="446925672"/>
      </c:barChart>
      <c:catAx>
        <c:axId val="446925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46925672"/>
        <c:crosses val="autoZero"/>
        <c:auto val="1"/>
        <c:lblAlgn val="ctr"/>
        <c:lblOffset val="100"/>
        <c:noMultiLvlLbl val="0"/>
      </c:catAx>
      <c:valAx>
        <c:axId val="44692567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  <a:latin typeface="Century" panose="02040604050505020304" pitchFamily="18" charset="0"/>
                  </a:rPr>
                  <a:t>log(Pre/Pos)</a:t>
                </a:r>
                <a:endParaRPr lang="ja-JP" altLang="en-US">
                  <a:solidFill>
                    <a:schemeClr val="tx1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Century" panose="0204060405050502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46925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Century" panose="020406040505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  <a:latin typeface="Century" panose="02040604050505020304" pitchFamily="18" charset="0"/>
                <a:ea typeface="ＭＳ 明朝" panose="02020609040205080304" pitchFamily="17" charset="-128"/>
              </a:rPr>
              <a:t>(b)</a:t>
            </a:r>
            <a:endParaRPr lang="ja-JP" altLang="en-US">
              <a:solidFill>
                <a:sysClr val="windowText" lastClr="000000"/>
              </a:solidFill>
              <a:latin typeface="Century" panose="02040604050505020304" pitchFamily="18" charset="0"/>
              <a:ea typeface="ＭＳ 明朝" panose="02020609040205080304" pitchFamily="17" charset="-128"/>
            </a:endParaRPr>
          </a:p>
        </c:rich>
      </c:tx>
      <c:layout>
        <c:manualLayout>
          <c:xMode val="edge"/>
          <c:yMode val="edge"/>
          <c:x val="7.2453121689550384E-2"/>
          <c:y val="2.24971992378789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ＭＳ 明朝" panose="02020609040205080304" pitchFamily="17" charset="-128"/>
              <a:ea typeface="ＭＳ 明朝" panose="02020609040205080304" pitchFamily="17" charset="-128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S1!$C$2</c:f>
              <c:strCache>
                <c:ptCount val="1"/>
                <c:pt idx="0">
                  <c:v>Spring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C$14:$C$16</c:f>
                <c:numCache>
                  <c:formatCode>General</c:formatCode>
                  <c:ptCount val="3"/>
                  <c:pt idx="0">
                    <c:v>0.32003417730943873</c:v>
                  </c:pt>
                  <c:pt idx="1">
                    <c:v>0.50780991676633158</c:v>
                  </c:pt>
                  <c:pt idx="2">
                    <c:v>0.29844169784786362</c:v>
                  </c:pt>
                </c:numCache>
              </c:numRef>
            </c:plus>
            <c:minus>
              <c:numRef>
                <c:f>FigS1!$C$14:$C$16</c:f>
                <c:numCache>
                  <c:formatCode>General</c:formatCode>
                  <c:ptCount val="3"/>
                  <c:pt idx="0">
                    <c:v>0.32003417730943873</c:v>
                  </c:pt>
                  <c:pt idx="1">
                    <c:v>0.50780991676633158</c:v>
                  </c:pt>
                  <c:pt idx="2">
                    <c:v>0.298441697847863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11:$B$13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C$11:$C$13</c:f>
              <c:numCache>
                <c:formatCode>General</c:formatCode>
                <c:ptCount val="3"/>
                <c:pt idx="0">
                  <c:v>1.4604624447142063</c:v>
                </c:pt>
                <c:pt idx="1">
                  <c:v>2.6712265657637304</c:v>
                </c:pt>
                <c:pt idx="2">
                  <c:v>1.21964728169186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96-024C-B1A2-BEE1F65927C8}"/>
            </c:ext>
          </c:extLst>
        </c:ser>
        <c:ser>
          <c:idx val="1"/>
          <c:order val="1"/>
          <c:tx>
            <c:strRef>
              <c:f>FigS1!$D$2</c:f>
              <c:strCache>
                <c:ptCount val="1"/>
                <c:pt idx="0">
                  <c:v>Summer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D$14:$D$16</c:f>
                <c:numCache>
                  <c:formatCode>General</c:formatCode>
                  <c:ptCount val="3"/>
                  <c:pt idx="0">
                    <c:v>0.40428403080300557</c:v>
                  </c:pt>
                  <c:pt idx="1">
                    <c:v>0.42329917757589974</c:v>
                  </c:pt>
                  <c:pt idx="2">
                    <c:v>0.4763412826279827</c:v>
                  </c:pt>
                </c:numCache>
              </c:numRef>
            </c:plus>
            <c:minus>
              <c:numRef>
                <c:f>FigS1!$D$14:$D$16</c:f>
                <c:numCache>
                  <c:formatCode>General</c:formatCode>
                  <c:ptCount val="3"/>
                  <c:pt idx="0">
                    <c:v>0.40428403080300557</c:v>
                  </c:pt>
                  <c:pt idx="1">
                    <c:v>0.42329917757589974</c:v>
                  </c:pt>
                  <c:pt idx="2">
                    <c:v>0.47634128262798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11:$B$13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D$11:$D$13</c:f>
              <c:numCache>
                <c:formatCode>General</c:formatCode>
                <c:ptCount val="3"/>
                <c:pt idx="0">
                  <c:v>1.3312066344540743</c:v>
                </c:pt>
                <c:pt idx="1">
                  <c:v>1.5011788911616701</c:v>
                </c:pt>
                <c:pt idx="2">
                  <c:v>-0.159603706216345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396-024C-B1A2-BEE1F65927C8}"/>
            </c:ext>
          </c:extLst>
        </c:ser>
        <c:ser>
          <c:idx val="2"/>
          <c:order val="2"/>
          <c:tx>
            <c:strRef>
              <c:f>FigS1!$E$2</c:f>
              <c:strCache>
                <c:ptCount val="1"/>
                <c:pt idx="0">
                  <c:v>Autumn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E$14:$E$16</c:f>
                <c:numCache>
                  <c:formatCode>General</c:formatCode>
                  <c:ptCount val="3"/>
                  <c:pt idx="0">
                    <c:v>0.65981384879913674</c:v>
                  </c:pt>
                  <c:pt idx="1">
                    <c:v>0.64896927143581673</c:v>
                  </c:pt>
                  <c:pt idx="2">
                    <c:v>0.38058125009371568</c:v>
                  </c:pt>
                </c:numCache>
              </c:numRef>
            </c:plus>
            <c:minus>
              <c:numRef>
                <c:f>FigS1!$E$14:$E$16</c:f>
                <c:numCache>
                  <c:formatCode>General</c:formatCode>
                  <c:ptCount val="3"/>
                  <c:pt idx="0">
                    <c:v>0.65981384879913674</c:v>
                  </c:pt>
                  <c:pt idx="1">
                    <c:v>0.64896927143581673</c:v>
                  </c:pt>
                  <c:pt idx="2">
                    <c:v>0.380581250093715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11:$B$13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E$11:$E$13</c:f>
              <c:numCache>
                <c:formatCode>General</c:formatCode>
                <c:ptCount val="3"/>
                <c:pt idx="0">
                  <c:v>1.7413820567645442</c:v>
                </c:pt>
                <c:pt idx="1">
                  <c:v>1.2559607551419913</c:v>
                </c:pt>
                <c:pt idx="2">
                  <c:v>2.1831040430667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396-024C-B1A2-BEE1F65927C8}"/>
            </c:ext>
          </c:extLst>
        </c:ser>
        <c:ser>
          <c:idx val="3"/>
          <c:order val="3"/>
          <c:tx>
            <c:strRef>
              <c:f>FigS1!$F$2</c:f>
              <c:strCache>
                <c:ptCount val="1"/>
                <c:pt idx="0">
                  <c:v>Winter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F$14:$F$16</c:f>
                <c:numCache>
                  <c:formatCode>General</c:formatCode>
                  <c:ptCount val="3"/>
                  <c:pt idx="0">
                    <c:v>0.70193270926143125</c:v>
                  </c:pt>
                  <c:pt idx="1">
                    <c:v>0.27780711670110092</c:v>
                  </c:pt>
                  <c:pt idx="2">
                    <c:v>0.50561244485819301</c:v>
                  </c:pt>
                </c:numCache>
              </c:numRef>
            </c:plus>
            <c:minus>
              <c:numRef>
                <c:f>FigS1!$F$14:$F$16</c:f>
                <c:numCache>
                  <c:formatCode>General</c:formatCode>
                  <c:ptCount val="3"/>
                  <c:pt idx="0">
                    <c:v>0.70193270926143125</c:v>
                  </c:pt>
                  <c:pt idx="1">
                    <c:v>0.27780711670110092</c:v>
                  </c:pt>
                  <c:pt idx="2">
                    <c:v>0.505612444858193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11:$B$13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F$11:$F$13</c:f>
              <c:numCache>
                <c:formatCode>General</c:formatCode>
                <c:ptCount val="3"/>
                <c:pt idx="0">
                  <c:v>3.1711699718491162</c:v>
                </c:pt>
                <c:pt idx="1">
                  <c:v>3.3948340515031892</c:v>
                </c:pt>
                <c:pt idx="2">
                  <c:v>1.6742162516240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396-024C-B1A2-BEE1F65927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6925280"/>
        <c:axId val="446925672"/>
      </c:barChart>
      <c:catAx>
        <c:axId val="446925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46925672"/>
        <c:crosses val="autoZero"/>
        <c:auto val="1"/>
        <c:lblAlgn val="ctr"/>
        <c:lblOffset val="100"/>
        <c:noMultiLvlLbl val="0"/>
      </c:catAx>
      <c:valAx>
        <c:axId val="44692567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  <a:latin typeface="Century" panose="02040604050505020304" pitchFamily="18" charset="0"/>
                  </a:rPr>
                  <a:t>log(Pre/Pos)</a:t>
                </a:r>
                <a:endParaRPr lang="ja-JP" altLang="en-US">
                  <a:solidFill>
                    <a:schemeClr val="tx1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Century" panose="0204060405050502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46925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Century" panose="020406040505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  <a:latin typeface="Century" panose="02040604050505020304" pitchFamily="18" charset="0"/>
                <a:ea typeface="ＭＳ 明朝" panose="02020609040205080304" pitchFamily="17" charset="-128"/>
              </a:rPr>
              <a:t>(c)</a:t>
            </a:r>
            <a:endParaRPr lang="ja-JP" altLang="en-US">
              <a:solidFill>
                <a:sysClr val="windowText" lastClr="000000"/>
              </a:solidFill>
              <a:latin typeface="Century" panose="02040604050505020304" pitchFamily="18" charset="0"/>
              <a:ea typeface="ＭＳ 明朝" panose="02020609040205080304" pitchFamily="17" charset="-128"/>
            </a:endParaRPr>
          </a:p>
        </c:rich>
      </c:tx>
      <c:layout>
        <c:manualLayout>
          <c:xMode val="edge"/>
          <c:yMode val="edge"/>
          <c:x val="7.2453121689550384E-2"/>
          <c:y val="2.24971992378789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ＭＳ 明朝" panose="02020609040205080304" pitchFamily="17" charset="-128"/>
              <a:ea typeface="ＭＳ 明朝" panose="02020609040205080304" pitchFamily="17" charset="-128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S1!$C$2</c:f>
              <c:strCache>
                <c:ptCount val="1"/>
                <c:pt idx="0">
                  <c:v>Spring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C$22:$C$2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FigS1!$C$22:$C$2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19:$B$21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C$19:$C$21</c:f>
              <c:numCache>
                <c:formatCode>General</c:formatCode>
                <c:ptCount val="3"/>
                <c:pt idx="0">
                  <c:v>4.3328218300878323</c:v>
                </c:pt>
                <c:pt idx="1">
                  <c:v>0</c:v>
                </c:pt>
                <c:pt idx="2">
                  <c:v>4.0137882844856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70-1841-A801-92824498D0BE}"/>
            </c:ext>
          </c:extLst>
        </c:ser>
        <c:ser>
          <c:idx val="1"/>
          <c:order val="1"/>
          <c:tx>
            <c:strRef>
              <c:f>FigS1!$D$2</c:f>
              <c:strCache>
                <c:ptCount val="1"/>
                <c:pt idx="0">
                  <c:v>Summer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D$22:$D$2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FigS1!$D$22:$D$2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19:$B$21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D$19:$D$21</c:f>
              <c:numCache>
                <c:formatCode>General</c:formatCode>
                <c:ptCount val="3"/>
                <c:pt idx="0">
                  <c:v>3.6208094273408014</c:v>
                </c:pt>
                <c:pt idx="1">
                  <c:v>2.4499690086760482</c:v>
                </c:pt>
                <c:pt idx="2">
                  <c:v>2.45593195564972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970-1841-A801-92824498D0BE}"/>
            </c:ext>
          </c:extLst>
        </c:ser>
        <c:ser>
          <c:idx val="2"/>
          <c:order val="2"/>
          <c:tx>
            <c:strRef>
              <c:f>FigS1!$E$2</c:f>
              <c:strCache>
                <c:ptCount val="1"/>
                <c:pt idx="0">
                  <c:v>Autumn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E$22:$E$24</c:f>
                <c:numCache>
                  <c:formatCode>General</c:formatCode>
                  <c:ptCount val="3"/>
                  <c:pt idx="0">
                    <c:v>7.8584910720782997E-2</c:v>
                  </c:pt>
                  <c:pt idx="1">
                    <c:v>9.8192897143452459E-2</c:v>
                  </c:pt>
                  <c:pt idx="2">
                    <c:v>1.3178136694871152</c:v>
                  </c:pt>
                </c:numCache>
              </c:numRef>
            </c:plus>
            <c:minus>
              <c:numRef>
                <c:f>FigS1!$E$22:$E$24</c:f>
                <c:numCache>
                  <c:formatCode>General</c:formatCode>
                  <c:ptCount val="3"/>
                  <c:pt idx="0">
                    <c:v>7.8584910720782997E-2</c:v>
                  </c:pt>
                  <c:pt idx="1">
                    <c:v>9.8192897143452459E-2</c:v>
                  </c:pt>
                  <c:pt idx="2">
                    <c:v>1.31781366948711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19:$B$21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E$19:$E$21</c:f>
              <c:numCache>
                <c:formatCode>General</c:formatCode>
                <c:ptCount val="3"/>
                <c:pt idx="0">
                  <c:v>1.6895997447016717</c:v>
                </c:pt>
                <c:pt idx="1">
                  <c:v>1.6419826367857726</c:v>
                </c:pt>
                <c:pt idx="2">
                  <c:v>1.925224379199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970-1841-A801-92824498D0BE}"/>
            </c:ext>
          </c:extLst>
        </c:ser>
        <c:ser>
          <c:idx val="3"/>
          <c:order val="3"/>
          <c:tx>
            <c:strRef>
              <c:f>FigS1!$F$2</c:f>
              <c:strCache>
                <c:ptCount val="1"/>
                <c:pt idx="0">
                  <c:v>Winter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1!$F$22:$F$24</c:f>
                <c:numCache>
                  <c:formatCode>General</c:formatCode>
                  <c:ptCount val="3"/>
                  <c:pt idx="0">
                    <c:v>6.2343202797991984E-3</c:v>
                  </c:pt>
                  <c:pt idx="1">
                    <c:v>0.13810320596947445</c:v>
                  </c:pt>
                  <c:pt idx="2">
                    <c:v>0.54766394099909055</c:v>
                  </c:pt>
                </c:numCache>
              </c:numRef>
            </c:plus>
            <c:minus>
              <c:numRef>
                <c:f>FigS1!$F$22:$F$24</c:f>
                <c:numCache>
                  <c:formatCode>General</c:formatCode>
                  <c:ptCount val="3"/>
                  <c:pt idx="0">
                    <c:v>6.2343202797991984E-3</c:v>
                  </c:pt>
                  <c:pt idx="1">
                    <c:v>0.13810320596947445</c:v>
                  </c:pt>
                  <c:pt idx="2">
                    <c:v>0.547663940999090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igS1!$B$19:$B$21</c:f>
              <c:strCache>
                <c:ptCount val="3"/>
                <c:pt idx="0">
                  <c:v>E. coli</c:v>
                </c:pt>
                <c:pt idx="1">
                  <c:v>TC-R</c:v>
                </c:pt>
                <c:pt idx="2">
                  <c:v>CEZ-R</c:v>
                </c:pt>
              </c:strCache>
            </c:strRef>
          </c:cat>
          <c:val>
            <c:numRef>
              <c:f>FigS1!$F$19:$F$21</c:f>
              <c:numCache>
                <c:formatCode>General</c:formatCode>
                <c:ptCount val="3"/>
                <c:pt idx="0">
                  <c:v>3.71804154932099</c:v>
                </c:pt>
                <c:pt idx="1">
                  <c:v>3.5694669701284623</c:v>
                </c:pt>
                <c:pt idx="2">
                  <c:v>1.5890566261573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970-1841-A801-92824498D0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6925280"/>
        <c:axId val="446925672"/>
      </c:barChart>
      <c:catAx>
        <c:axId val="446925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46925672"/>
        <c:crosses val="autoZero"/>
        <c:auto val="1"/>
        <c:lblAlgn val="ctr"/>
        <c:lblOffset val="100"/>
        <c:noMultiLvlLbl val="0"/>
      </c:catAx>
      <c:valAx>
        <c:axId val="44692567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  <a:latin typeface="Century" panose="02040604050505020304" pitchFamily="18" charset="0"/>
                  </a:rPr>
                  <a:t>log(Pre/Pos)</a:t>
                </a:r>
                <a:endParaRPr lang="ja-JP" altLang="en-US">
                  <a:solidFill>
                    <a:schemeClr val="tx1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Century" panose="0204060405050502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46925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Century" panose="020406040505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pPr>
            <a:r>
              <a:rPr lang="en-US" altLang="ja-JP">
                <a:solidFill>
                  <a:schemeClr val="tx1"/>
                </a:solidFill>
                <a:latin typeface="Century" panose="02040604050505020304" pitchFamily="18" charset="0"/>
                <a:ea typeface="ＭＳ 明朝" panose="02020609040205080304" pitchFamily="17" charset="-128"/>
              </a:rPr>
              <a:t>(a)</a:t>
            </a:r>
            <a:endParaRPr lang="ja-JP" altLang="en-US">
              <a:solidFill>
                <a:schemeClr val="tx1"/>
              </a:solidFill>
              <a:latin typeface="Century" panose="02040604050505020304" pitchFamily="18" charset="0"/>
              <a:ea typeface="ＭＳ 明朝" panose="02020609040205080304" pitchFamily="17" charset="-128"/>
            </a:endParaRPr>
          </a:p>
        </c:rich>
      </c:tx>
      <c:layout>
        <c:manualLayout>
          <c:xMode val="edge"/>
          <c:yMode val="edge"/>
          <c:x val="6.7418817418488111E-2"/>
          <c:y val="3.3279662719498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ＭＳ 明朝" panose="02020609040205080304" pitchFamily="17" charset="-128"/>
              <a:ea typeface="ＭＳ 明朝" panose="02020609040205080304" pitchFamily="17" charset="-128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S3!$C$2</c:f>
              <c:strCache>
                <c:ptCount val="1"/>
                <c:pt idx="0">
                  <c:v>Spring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C$9:$C$14</c:f>
                <c:numCache>
                  <c:formatCode>General</c:formatCode>
                  <c:ptCount val="6"/>
                  <c:pt idx="0">
                    <c:v>0.58248504948028079</c:v>
                  </c:pt>
                  <c:pt idx="1">
                    <c:v>0.42614993628909925</c:v>
                  </c:pt>
                  <c:pt idx="2">
                    <c:v>0.29095372823444821</c:v>
                  </c:pt>
                  <c:pt idx="3">
                    <c:v>0.38373425567006297</c:v>
                  </c:pt>
                  <c:pt idx="4">
                    <c:v>1.2578903468620053</c:v>
                  </c:pt>
                  <c:pt idx="5">
                    <c:v>0.29252055136705096</c:v>
                  </c:pt>
                </c:numCache>
              </c:numRef>
            </c:plus>
            <c:minus>
              <c:numRef>
                <c:f>FigS3!$C$9:$C$14</c:f>
                <c:numCache>
                  <c:formatCode>General</c:formatCode>
                  <c:ptCount val="6"/>
                  <c:pt idx="0">
                    <c:v>0.58248504948028079</c:v>
                  </c:pt>
                  <c:pt idx="1">
                    <c:v>0.42614993628909925</c:v>
                  </c:pt>
                  <c:pt idx="2">
                    <c:v>0.29095372823444821</c:v>
                  </c:pt>
                  <c:pt idx="3">
                    <c:v>0.38373425567006297</c:v>
                  </c:pt>
                  <c:pt idx="4">
                    <c:v>1.2578903468620053</c:v>
                  </c:pt>
                  <c:pt idx="5">
                    <c:v>0.292520551367050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3:$B$7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C$3:$C$7</c:f>
              <c:numCache>
                <c:formatCode>General</c:formatCode>
                <c:ptCount val="5"/>
                <c:pt idx="0">
                  <c:v>-0.52395561083488529</c:v>
                </c:pt>
                <c:pt idx="1">
                  <c:v>6.6212185254151845E-2</c:v>
                </c:pt>
                <c:pt idx="2">
                  <c:v>-0.95241133127652899</c:v>
                </c:pt>
                <c:pt idx="3">
                  <c:v>-0.27876217184339502</c:v>
                </c:pt>
                <c:pt idx="4">
                  <c:v>-0.416790919100052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28-9544-B336-8F2BEBDB81A6}"/>
            </c:ext>
          </c:extLst>
        </c:ser>
        <c:ser>
          <c:idx val="1"/>
          <c:order val="1"/>
          <c:tx>
            <c:strRef>
              <c:f>FigS3!$D$2</c:f>
              <c:strCache>
                <c:ptCount val="1"/>
                <c:pt idx="0">
                  <c:v>Summer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D$9:$D$14</c:f>
                <c:numCache>
                  <c:formatCode>General</c:formatCode>
                  <c:ptCount val="6"/>
                  <c:pt idx="0">
                    <c:v>0.36508585466186838</c:v>
                  </c:pt>
                  <c:pt idx="1">
                    <c:v>0.91662756919977573</c:v>
                  </c:pt>
                  <c:pt idx="2">
                    <c:v>0.14823819077194711</c:v>
                  </c:pt>
                  <c:pt idx="3">
                    <c:v>0.57334246801718625</c:v>
                  </c:pt>
                  <c:pt idx="4">
                    <c:v>1.389438042929489</c:v>
                  </c:pt>
                  <c:pt idx="5">
                    <c:v>0.32887572565648815</c:v>
                  </c:pt>
                </c:numCache>
              </c:numRef>
            </c:plus>
            <c:minus>
              <c:numRef>
                <c:f>FigS3!$D$9:$D$14</c:f>
                <c:numCache>
                  <c:formatCode>General</c:formatCode>
                  <c:ptCount val="6"/>
                  <c:pt idx="0">
                    <c:v>0.36508585466186838</c:v>
                  </c:pt>
                  <c:pt idx="1">
                    <c:v>0.91662756919977573</c:v>
                  </c:pt>
                  <c:pt idx="2">
                    <c:v>0.14823819077194711</c:v>
                  </c:pt>
                  <c:pt idx="3">
                    <c:v>0.57334246801718625</c:v>
                  </c:pt>
                  <c:pt idx="4">
                    <c:v>1.389438042929489</c:v>
                  </c:pt>
                  <c:pt idx="5">
                    <c:v>0.328875725656488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3:$B$7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D$3:$D$7</c:f>
              <c:numCache>
                <c:formatCode>General</c:formatCode>
                <c:ptCount val="5"/>
                <c:pt idx="0">
                  <c:v>-0.24486161073907842</c:v>
                </c:pt>
                <c:pt idx="1">
                  <c:v>0.86558502870911069</c:v>
                </c:pt>
                <c:pt idx="2">
                  <c:v>1.2822975605804068</c:v>
                </c:pt>
                <c:pt idx="3">
                  <c:v>0.83704330728906018</c:v>
                </c:pt>
                <c:pt idx="4">
                  <c:v>-0.23883701127762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428-9544-B336-8F2BEBDB81A6}"/>
            </c:ext>
          </c:extLst>
        </c:ser>
        <c:ser>
          <c:idx val="2"/>
          <c:order val="2"/>
          <c:tx>
            <c:strRef>
              <c:f>FigS3!$E$2</c:f>
              <c:strCache>
                <c:ptCount val="1"/>
                <c:pt idx="0">
                  <c:v>Autumn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E$9:$E$14</c:f>
                <c:numCache>
                  <c:formatCode>General</c:formatCode>
                  <c:ptCount val="6"/>
                  <c:pt idx="0">
                    <c:v>0.44762135337977099</c:v>
                  </c:pt>
                  <c:pt idx="1">
                    <c:v>0.1515412696328835</c:v>
                  </c:pt>
                  <c:pt idx="2">
                    <c:v>0.38050391867695277</c:v>
                  </c:pt>
                  <c:pt idx="3">
                    <c:v>0.55234637812861387</c:v>
                  </c:pt>
                  <c:pt idx="4">
                    <c:v>0.45877526289403331</c:v>
                  </c:pt>
                  <c:pt idx="5">
                    <c:v>0.28401485603058085</c:v>
                  </c:pt>
                </c:numCache>
              </c:numRef>
            </c:plus>
            <c:minus>
              <c:numRef>
                <c:f>FigS3!$E$9:$E$14</c:f>
                <c:numCache>
                  <c:formatCode>General</c:formatCode>
                  <c:ptCount val="6"/>
                  <c:pt idx="0">
                    <c:v>0.44762135337977099</c:v>
                  </c:pt>
                  <c:pt idx="1">
                    <c:v>0.1515412696328835</c:v>
                  </c:pt>
                  <c:pt idx="2">
                    <c:v>0.38050391867695277</c:v>
                  </c:pt>
                  <c:pt idx="3">
                    <c:v>0.55234637812861387</c:v>
                  </c:pt>
                  <c:pt idx="4">
                    <c:v>0.45877526289403331</c:v>
                  </c:pt>
                  <c:pt idx="5">
                    <c:v>0.284014856030580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3:$B$7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E$3:$E$7</c:f>
              <c:numCache>
                <c:formatCode>General</c:formatCode>
                <c:ptCount val="5"/>
                <c:pt idx="0">
                  <c:v>0.1907343503601846</c:v>
                </c:pt>
                <c:pt idx="1">
                  <c:v>0.42508964088506063</c:v>
                </c:pt>
                <c:pt idx="2">
                  <c:v>1.2186136605387139</c:v>
                </c:pt>
                <c:pt idx="3">
                  <c:v>0.63200523591753721</c:v>
                </c:pt>
                <c:pt idx="4">
                  <c:v>1.3047522643239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428-9544-B336-8F2BEBDB81A6}"/>
            </c:ext>
          </c:extLst>
        </c:ser>
        <c:ser>
          <c:idx val="3"/>
          <c:order val="3"/>
          <c:tx>
            <c:strRef>
              <c:f>FigS3!$F$2</c:f>
              <c:strCache>
                <c:ptCount val="1"/>
                <c:pt idx="0">
                  <c:v>Winter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F$9:$F$14</c:f>
                <c:numCache>
                  <c:formatCode>General</c:formatCode>
                  <c:ptCount val="6"/>
                  <c:pt idx="0">
                    <c:v>0.78607253227300333</c:v>
                  </c:pt>
                  <c:pt idx="1">
                    <c:v>0.42599959388554515</c:v>
                  </c:pt>
                  <c:pt idx="2">
                    <c:v>0.55437658630986641</c:v>
                  </c:pt>
                  <c:pt idx="3">
                    <c:v>0.68957580783055827</c:v>
                  </c:pt>
                  <c:pt idx="4">
                    <c:v>0.79254771772619781</c:v>
                  </c:pt>
                  <c:pt idx="5">
                    <c:v>0.38108047868199246</c:v>
                  </c:pt>
                </c:numCache>
              </c:numRef>
            </c:plus>
            <c:minus>
              <c:numRef>
                <c:f>FigS3!$F$9:$F$14</c:f>
                <c:numCache>
                  <c:formatCode>General</c:formatCode>
                  <c:ptCount val="6"/>
                  <c:pt idx="0">
                    <c:v>0.78607253227300333</c:v>
                  </c:pt>
                  <c:pt idx="1">
                    <c:v>0.42599959388554515</c:v>
                  </c:pt>
                  <c:pt idx="2">
                    <c:v>0.55437658630986641</c:v>
                  </c:pt>
                  <c:pt idx="3">
                    <c:v>0.68957580783055827</c:v>
                  </c:pt>
                  <c:pt idx="4">
                    <c:v>0.79254771772619781</c:v>
                  </c:pt>
                  <c:pt idx="5">
                    <c:v>0.381080478681992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3:$B$7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F$3:$F$7</c:f>
              <c:numCache>
                <c:formatCode>General</c:formatCode>
                <c:ptCount val="5"/>
                <c:pt idx="0">
                  <c:v>-0.40370942313130853</c:v>
                </c:pt>
                <c:pt idx="1">
                  <c:v>0.35301289995431606</c:v>
                </c:pt>
                <c:pt idx="2">
                  <c:v>0.23230532618504096</c:v>
                </c:pt>
                <c:pt idx="3">
                  <c:v>-0.89992157122022787</c:v>
                </c:pt>
                <c:pt idx="4">
                  <c:v>0.37843276511151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428-9544-B336-8F2BEBDB81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565224"/>
        <c:axId val="582569144"/>
      </c:barChart>
      <c:catAx>
        <c:axId val="582565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582569144"/>
        <c:crosses val="autoZero"/>
        <c:auto val="1"/>
        <c:lblAlgn val="ctr"/>
        <c:lblOffset val="100"/>
        <c:noMultiLvlLbl val="0"/>
      </c:catAx>
      <c:valAx>
        <c:axId val="5825691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  <a:latin typeface="Century" panose="02040604050505020304" pitchFamily="18" charset="0"/>
                  </a:rPr>
                  <a:t>log(Pre/Pos)</a:t>
                </a:r>
                <a:endParaRPr lang="ja-JP" altLang="en-US">
                  <a:solidFill>
                    <a:schemeClr val="tx1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Century" panose="0204060405050502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0_ 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5825652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Century" panose="020406040505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pPr>
            <a:r>
              <a:rPr lang="en-US" altLang="ja-JP">
                <a:solidFill>
                  <a:schemeClr val="tx1"/>
                </a:solidFill>
                <a:latin typeface="Century" panose="02040604050505020304" pitchFamily="18" charset="0"/>
                <a:ea typeface="ＭＳ 明朝" panose="02020609040205080304" pitchFamily="17" charset="-128"/>
              </a:rPr>
              <a:t>(b)</a:t>
            </a:r>
            <a:endParaRPr lang="ja-JP" altLang="en-US">
              <a:solidFill>
                <a:schemeClr val="tx1"/>
              </a:solidFill>
              <a:latin typeface="Century" panose="02040604050505020304" pitchFamily="18" charset="0"/>
              <a:ea typeface="ＭＳ 明朝" panose="02020609040205080304" pitchFamily="17" charset="-128"/>
            </a:endParaRPr>
          </a:p>
        </c:rich>
      </c:tx>
      <c:layout>
        <c:manualLayout>
          <c:xMode val="edge"/>
          <c:yMode val="edge"/>
          <c:x val="6.7418817418488111E-2"/>
          <c:y val="3.3279662719498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ＭＳ 明朝" panose="02020609040205080304" pitchFamily="17" charset="-128"/>
              <a:ea typeface="ＭＳ 明朝" panose="02020609040205080304" pitchFamily="17" charset="-128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S3!$C$16</c:f>
              <c:strCache>
                <c:ptCount val="1"/>
                <c:pt idx="0">
                  <c:v>Spring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C$23:$C$28</c:f>
                <c:numCache>
                  <c:formatCode>General</c:formatCode>
                  <c:ptCount val="6"/>
                  <c:pt idx="0">
                    <c:v>0.70042531585514711</c:v>
                  </c:pt>
                  <c:pt idx="1">
                    <c:v>0.34058206764999321</c:v>
                  </c:pt>
                  <c:pt idx="2">
                    <c:v>0.62139806030943801</c:v>
                  </c:pt>
                  <c:pt idx="3">
                    <c:v>0.32858829749237095</c:v>
                  </c:pt>
                  <c:pt idx="4">
                    <c:v>0.82057702501497398</c:v>
                  </c:pt>
                  <c:pt idx="5">
                    <c:v>0.66271602747282599</c:v>
                  </c:pt>
                </c:numCache>
              </c:numRef>
            </c:plus>
            <c:minus>
              <c:numRef>
                <c:f>FigS3!$C$23:$C$28</c:f>
                <c:numCache>
                  <c:formatCode>General</c:formatCode>
                  <c:ptCount val="6"/>
                  <c:pt idx="0">
                    <c:v>0.70042531585514711</c:v>
                  </c:pt>
                  <c:pt idx="1">
                    <c:v>0.34058206764999321</c:v>
                  </c:pt>
                  <c:pt idx="2">
                    <c:v>0.62139806030943801</c:v>
                  </c:pt>
                  <c:pt idx="3">
                    <c:v>0.32858829749237095</c:v>
                  </c:pt>
                  <c:pt idx="4">
                    <c:v>0.82057702501497398</c:v>
                  </c:pt>
                  <c:pt idx="5">
                    <c:v>0.662716027472825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17:$B$21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C$17:$C$21</c:f>
              <c:numCache>
                <c:formatCode>General</c:formatCode>
                <c:ptCount val="5"/>
                <c:pt idx="0">
                  <c:v>1.2478211510437991</c:v>
                </c:pt>
                <c:pt idx="1">
                  <c:v>0.69975825258072755</c:v>
                </c:pt>
                <c:pt idx="2">
                  <c:v>1.2623502380686749</c:v>
                </c:pt>
                <c:pt idx="3">
                  <c:v>0.21418011969991801</c:v>
                </c:pt>
                <c:pt idx="4">
                  <c:v>1.38052077063004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C7-A047-90A8-45E35BB1FCBF}"/>
            </c:ext>
          </c:extLst>
        </c:ser>
        <c:ser>
          <c:idx val="1"/>
          <c:order val="1"/>
          <c:tx>
            <c:strRef>
              <c:f>FigS3!$D$16</c:f>
              <c:strCache>
                <c:ptCount val="1"/>
                <c:pt idx="0">
                  <c:v>Summer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D$23:$D$28</c:f>
                <c:numCache>
                  <c:formatCode>General</c:formatCode>
                  <c:ptCount val="6"/>
                  <c:pt idx="0">
                    <c:v>0.23310776052927742</c:v>
                  </c:pt>
                  <c:pt idx="1">
                    <c:v>0.79173957365339809</c:v>
                  </c:pt>
                  <c:pt idx="2">
                    <c:v>0.6299997271747666</c:v>
                  </c:pt>
                  <c:pt idx="3">
                    <c:v>0.60114134151447096</c:v>
                  </c:pt>
                  <c:pt idx="4">
                    <c:v>0.26647266751339266</c:v>
                  </c:pt>
                  <c:pt idx="5">
                    <c:v>0.34065890071842553</c:v>
                  </c:pt>
                </c:numCache>
              </c:numRef>
            </c:plus>
            <c:minus>
              <c:numRef>
                <c:f>FigS3!$D$23:$D$28</c:f>
                <c:numCache>
                  <c:formatCode>General</c:formatCode>
                  <c:ptCount val="6"/>
                  <c:pt idx="0">
                    <c:v>0.23310776052927742</c:v>
                  </c:pt>
                  <c:pt idx="1">
                    <c:v>0.79173957365339809</c:v>
                  </c:pt>
                  <c:pt idx="2">
                    <c:v>0.6299997271747666</c:v>
                  </c:pt>
                  <c:pt idx="3">
                    <c:v>0.60114134151447096</c:v>
                  </c:pt>
                  <c:pt idx="4">
                    <c:v>0.26647266751339266</c:v>
                  </c:pt>
                  <c:pt idx="5">
                    <c:v>0.340658900718425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17:$B$21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D$17:$D$21</c:f>
              <c:numCache>
                <c:formatCode>General</c:formatCode>
                <c:ptCount val="5"/>
                <c:pt idx="0">
                  <c:v>1.072820253389225</c:v>
                </c:pt>
                <c:pt idx="1">
                  <c:v>0.97636502127006108</c:v>
                </c:pt>
                <c:pt idx="2">
                  <c:v>2.1717219495903439</c:v>
                </c:pt>
                <c:pt idx="3">
                  <c:v>0.58880021374829505</c:v>
                </c:pt>
                <c:pt idx="4">
                  <c:v>1.3197342801408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C7-A047-90A8-45E35BB1FCBF}"/>
            </c:ext>
          </c:extLst>
        </c:ser>
        <c:ser>
          <c:idx val="2"/>
          <c:order val="2"/>
          <c:tx>
            <c:strRef>
              <c:f>FigS3!$E$16</c:f>
              <c:strCache>
                <c:ptCount val="1"/>
                <c:pt idx="0">
                  <c:v>Autumn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E$23:$E$28</c:f>
                <c:numCache>
                  <c:formatCode>General</c:formatCode>
                  <c:ptCount val="6"/>
                  <c:pt idx="0">
                    <c:v>0.41622776474583711</c:v>
                  </c:pt>
                  <c:pt idx="1">
                    <c:v>0.34258687452432707</c:v>
                  </c:pt>
                  <c:pt idx="2">
                    <c:v>0.3218889209994874</c:v>
                  </c:pt>
                  <c:pt idx="3">
                    <c:v>0.35374400478979318</c:v>
                  </c:pt>
                  <c:pt idx="4">
                    <c:v>0.42191819555295945</c:v>
                  </c:pt>
                  <c:pt idx="5">
                    <c:v>0.19390288548636417</c:v>
                  </c:pt>
                </c:numCache>
              </c:numRef>
            </c:plus>
            <c:minus>
              <c:numRef>
                <c:f>FigS3!$E$23:$E$28</c:f>
                <c:numCache>
                  <c:formatCode>General</c:formatCode>
                  <c:ptCount val="6"/>
                  <c:pt idx="0">
                    <c:v>0.41622776474583711</c:v>
                  </c:pt>
                  <c:pt idx="1">
                    <c:v>0.34258687452432707</c:v>
                  </c:pt>
                  <c:pt idx="2">
                    <c:v>0.3218889209994874</c:v>
                  </c:pt>
                  <c:pt idx="3">
                    <c:v>0.35374400478979318</c:v>
                  </c:pt>
                  <c:pt idx="4">
                    <c:v>0.42191819555295945</c:v>
                  </c:pt>
                  <c:pt idx="5">
                    <c:v>0.193902885486364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17:$B$21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E$17:$E$21</c:f>
              <c:numCache>
                <c:formatCode>General</c:formatCode>
                <c:ptCount val="5"/>
                <c:pt idx="0">
                  <c:v>0.67760156361532431</c:v>
                </c:pt>
                <c:pt idx="1">
                  <c:v>1.0162147565127446</c:v>
                </c:pt>
                <c:pt idx="2">
                  <c:v>1.3707940109443824</c:v>
                </c:pt>
                <c:pt idx="3">
                  <c:v>-0.37360178392422866</c:v>
                </c:pt>
                <c:pt idx="4">
                  <c:v>-5.543873679313815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AC7-A047-90A8-45E35BB1FCBF}"/>
            </c:ext>
          </c:extLst>
        </c:ser>
        <c:ser>
          <c:idx val="3"/>
          <c:order val="3"/>
          <c:tx>
            <c:strRef>
              <c:f>FigS3!$F$16</c:f>
              <c:strCache>
                <c:ptCount val="1"/>
                <c:pt idx="0">
                  <c:v>Winter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F$23:$F$28</c:f>
                <c:numCache>
                  <c:formatCode>General</c:formatCode>
                  <c:ptCount val="6"/>
                  <c:pt idx="0">
                    <c:v>0.49150221092791496</c:v>
                  </c:pt>
                  <c:pt idx="1">
                    <c:v>0.40817111667698408</c:v>
                  </c:pt>
                  <c:pt idx="2">
                    <c:v>0.59187742160458312</c:v>
                  </c:pt>
                  <c:pt idx="3">
                    <c:v>0.26857413748841197</c:v>
                  </c:pt>
                  <c:pt idx="4">
                    <c:v>3.5679639300961206E-2</c:v>
                  </c:pt>
                  <c:pt idx="5">
                    <c:v>0.86123246035091416</c:v>
                  </c:pt>
                </c:numCache>
              </c:numRef>
            </c:plus>
            <c:minus>
              <c:numRef>
                <c:f>FigS3!$F$23:$F$28</c:f>
                <c:numCache>
                  <c:formatCode>General</c:formatCode>
                  <c:ptCount val="6"/>
                  <c:pt idx="0">
                    <c:v>0.49150221092791496</c:v>
                  </c:pt>
                  <c:pt idx="1">
                    <c:v>0.40817111667698408</c:v>
                  </c:pt>
                  <c:pt idx="2">
                    <c:v>0.59187742160458312</c:v>
                  </c:pt>
                  <c:pt idx="3">
                    <c:v>0.26857413748841197</c:v>
                  </c:pt>
                  <c:pt idx="4">
                    <c:v>3.5679639300961206E-2</c:v>
                  </c:pt>
                  <c:pt idx="5">
                    <c:v>0.861232460350914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17:$B$21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F$17:$F$21</c:f>
              <c:numCache>
                <c:formatCode>General</c:formatCode>
                <c:ptCount val="5"/>
                <c:pt idx="0">
                  <c:v>0.57863718709961598</c:v>
                </c:pt>
                <c:pt idx="1">
                  <c:v>0.9888876152640611</c:v>
                </c:pt>
                <c:pt idx="2">
                  <c:v>0.44315857746408466</c:v>
                </c:pt>
                <c:pt idx="3">
                  <c:v>1.5951000166284737E-4</c:v>
                </c:pt>
                <c:pt idx="4">
                  <c:v>-0.218733015030546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AC7-A047-90A8-45E35BB1FC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565224"/>
        <c:axId val="582569144"/>
      </c:barChart>
      <c:catAx>
        <c:axId val="582565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582569144"/>
        <c:crosses val="autoZero"/>
        <c:auto val="1"/>
        <c:lblAlgn val="ctr"/>
        <c:lblOffset val="100"/>
        <c:noMultiLvlLbl val="0"/>
      </c:catAx>
      <c:valAx>
        <c:axId val="5825691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  <a:latin typeface="Century" panose="02040604050505020304" pitchFamily="18" charset="0"/>
                  </a:rPr>
                  <a:t>log(Pre/Pos)</a:t>
                </a:r>
                <a:endParaRPr lang="ja-JP" altLang="en-US">
                  <a:solidFill>
                    <a:schemeClr val="tx1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Century" panose="0204060405050502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0_ 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5825652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Century" panose="020406040505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pPr>
            <a:r>
              <a:rPr lang="en-US" altLang="ja-JP">
                <a:solidFill>
                  <a:schemeClr val="tx1"/>
                </a:solidFill>
                <a:latin typeface="Century" panose="02040604050505020304" pitchFamily="18" charset="0"/>
                <a:ea typeface="ＭＳ 明朝" panose="02020609040205080304" pitchFamily="17" charset="-128"/>
              </a:rPr>
              <a:t>(c)</a:t>
            </a:r>
            <a:endParaRPr lang="ja-JP" altLang="en-US">
              <a:solidFill>
                <a:schemeClr val="tx1"/>
              </a:solidFill>
              <a:latin typeface="Century" panose="02040604050505020304" pitchFamily="18" charset="0"/>
              <a:ea typeface="ＭＳ 明朝" panose="02020609040205080304" pitchFamily="17" charset="-128"/>
            </a:endParaRPr>
          </a:p>
        </c:rich>
      </c:tx>
      <c:layout>
        <c:manualLayout>
          <c:xMode val="edge"/>
          <c:yMode val="edge"/>
          <c:x val="6.7418817418488111E-2"/>
          <c:y val="3.3279662719498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ＭＳ 明朝" panose="02020609040205080304" pitchFamily="17" charset="-128"/>
              <a:ea typeface="ＭＳ 明朝" panose="02020609040205080304" pitchFamily="17" charset="-128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S3!$C$30</c:f>
              <c:strCache>
                <c:ptCount val="1"/>
                <c:pt idx="0">
                  <c:v>Spring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C$37:$C$4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FigS3!$C$37:$C$4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31:$B$35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C$31:$C$35</c:f>
              <c:numCache>
                <c:formatCode>General</c:formatCode>
                <c:ptCount val="5"/>
                <c:pt idx="0">
                  <c:v>-0.52063527547817223</c:v>
                </c:pt>
                <c:pt idx="1">
                  <c:v>0.17284865203189215</c:v>
                </c:pt>
                <c:pt idx="2">
                  <c:v>0.34475220294841158</c:v>
                </c:pt>
                <c:pt idx="3">
                  <c:v>-0.5472439294721867</c:v>
                </c:pt>
                <c:pt idx="4">
                  <c:v>1.65103442794324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DC-1141-9A59-9560B3815BCE}"/>
            </c:ext>
          </c:extLst>
        </c:ser>
        <c:ser>
          <c:idx val="1"/>
          <c:order val="1"/>
          <c:tx>
            <c:strRef>
              <c:f>FigS3!$D$30</c:f>
              <c:strCache>
                <c:ptCount val="1"/>
                <c:pt idx="0">
                  <c:v>Summer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D$37:$D$4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FigS3!$D$37:$D$4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31:$B$35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D$31:$D$35</c:f>
              <c:numCache>
                <c:formatCode>General</c:formatCode>
                <c:ptCount val="5"/>
                <c:pt idx="0">
                  <c:v>0.53081722489969341</c:v>
                </c:pt>
                <c:pt idx="1">
                  <c:v>1.9148446728148798</c:v>
                </c:pt>
                <c:pt idx="2">
                  <c:v>2.8523538412750278</c:v>
                </c:pt>
                <c:pt idx="3">
                  <c:v>0.58316077502960884</c:v>
                </c:pt>
                <c:pt idx="4">
                  <c:v>1.53013649443312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DC-1141-9A59-9560B3815BCE}"/>
            </c:ext>
          </c:extLst>
        </c:ser>
        <c:ser>
          <c:idx val="2"/>
          <c:order val="2"/>
          <c:tx>
            <c:strRef>
              <c:f>FigS3!$E$30</c:f>
              <c:strCache>
                <c:ptCount val="1"/>
                <c:pt idx="0">
                  <c:v>Autumn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E$37:$E$42</c:f>
                <c:numCache>
                  <c:formatCode>General</c:formatCode>
                  <c:ptCount val="6"/>
                  <c:pt idx="0">
                    <c:v>1.0457357464452963</c:v>
                  </c:pt>
                  <c:pt idx="1">
                    <c:v>0.62351511781922664</c:v>
                  </c:pt>
                  <c:pt idx="2">
                    <c:v>0.15035649510679128</c:v>
                  </c:pt>
                  <c:pt idx="3">
                    <c:v>0.48559163905685465</c:v>
                  </c:pt>
                  <c:pt idx="4">
                    <c:v>0.28544758490114036</c:v>
                  </c:pt>
                  <c:pt idx="5">
                    <c:v>1.0649110993358037</c:v>
                  </c:pt>
                </c:numCache>
              </c:numRef>
            </c:plus>
            <c:minus>
              <c:numRef>
                <c:f>FigS3!$E$37:$E$42</c:f>
                <c:numCache>
                  <c:formatCode>General</c:formatCode>
                  <c:ptCount val="6"/>
                  <c:pt idx="0">
                    <c:v>1.0457357464452963</c:v>
                  </c:pt>
                  <c:pt idx="1">
                    <c:v>0.62351511781922664</c:v>
                  </c:pt>
                  <c:pt idx="2">
                    <c:v>0.15035649510679128</c:v>
                  </c:pt>
                  <c:pt idx="3">
                    <c:v>0.48559163905685465</c:v>
                  </c:pt>
                  <c:pt idx="4">
                    <c:v>0.28544758490114036</c:v>
                  </c:pt>
                  <c:pt idx="5">
                    <c:v>1.06491109933580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31:$B$35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E$31:$E$35</c:f>
              <c:numCache>
                <c:formatCode>General</c:formatCode>
                <c:ptCount val="5"/>
                <c:pt idx="0">
                  <c:v>-0.83746859918690575</c:v>
                </c:pt>
                <c:pt idx="1">
                  <c:v>-0.20366071687562659</c:v>
                </c:pt>
                <c:pt idx="2">
                  <c:v>1.2028519608543404</c:v>
                </c:pt>
                <c:pt idx="3">
                  <c:v>-0.26251872923801911</c:v>
                </c:pt>
                <c:pt idx="4">
                  <c:v>0.285447584901140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9DC-1141-9A59-9560B3815BCE}"/>
            </c:ext>
          </c:extLst>
        </c:ser>
        <c:ser>
          <c:idx val="3"/>
          <c:order val="3"/>
          <c:tx>
            <c:strRef>
              <c:f>FigS3!$F$30</c:f>
              <c:strCache>
                <c:ptCount val="1"/>
                <c:pt idx="0">
                  <c:v>Winter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S3!$F$37:$F$42</c:f>
                <c:numCache>
                  <c:formatCode>General</c:formatCode>
                  <c:ptCount val="6"/>
                  <c:pt idx="0">
                    <c:v>4.4586769553908494E-2</c:v>
                  </c:pt>
                  <c:pt idx="1">
                    <c:v>0.19547778441266311</c:v>
                  </c:pt>
                  <c:pt idx="2">
                    <c:v>0.95618870700990177</c:v>
                  </c:pt>
                  <c:pt idx="3">
                    <c:v>0.16803660936848536</c:v>
                  </c:pt>
                  <c:pt idx="4">
                    <c:v>4.9871127426965194E-2</c:v>
                  </c:pt>
                  <c:pt idx="5">
                    <c:v>8.2316041802157583E-2</c:v>
                  </c:pt>
                </c:numCache>
              </c:numRef>
            </c:plus>
            <c:minus>
              <c:numRef>
                <c:f>FigS3!$F$37:$F$42</c:f>
                <c:numCache>
                  <c:formatCode>General</c:formatCode>
                  <c:ptCount val="6"/>
                  <c:pt idx="0">
                    <c:v>4.4586769553908494E-2</c:v>
                  </c:pt>
                  <c:pt idx="1">
                    <c:v>0.19547778441266311</c:v>
                  </c:pt>
                  <c:pt idx="2">
                    <c:v>0.95618870700990177</c:v>
                  </c:pt>
                  <c:pt idx="3">
                    <c:v>0.16803660936848536</c:v>
                  </c:pt>
                  <c:pt idx="4">
                    <c:v>4.9871127426965194E-2</c:v>
                  </c:pt>
                  <c:pt idx="5">
                    <c:v>8.231604180215758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S3!$B$31:$B$35</c:f>
              <c:strCache>
                <c:ptCount val="5"/>
                <c:pt idx="0">
                  <c:v>tetA</c:v>
                </c:pt>
                <c:pt idx="1">
                  <c:v>tetB</c:v>
                </c:pt>
                <c:pt idx="2">
                  <c:v>TEM</c:v>
                </c:pt>
                <c:pt idx="3">
                  <c:v>SHV</c:v>
                </c:pt>
                <c:pt idx="4">
                  <c:v>CTX-M</c:v>
                </c:pt>
              </c:strCache>
            </c:strRef>
          </c:cat>
          <c:val>
            <c:numRef>
              <c:f>FigS3!$F$31:$F$35</c:f>
              <c:numCache>
                <c:formatCode>General</c:formatCode>
                <c:ptCount val="5"/>
                <c:pt idx="0">
                  <c:v>0.24671345819829593</c:v>
                </c:pt>
                <c:pt idx="1">
                  <c:v>1.3274602483971054</c:v>
                </c:pt>
                <c:pt idx="2">
                  <c:v>1.04602279085185</c:v>
                </c:pt>
                <c:pt idx="3">
                  <c:v>0.96759623340984469</c:v>
                </c:pt>
                <c:pt idx="4">
                  <c:v>4.98711274269652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9DC-1141-9A59-9560B3815B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565224"/>
        <c:axId val="582569144"/>
      </c:barChart>
      <c:catAx>
        <c:axId val="582565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582569144"/>
        <c:crosses val="autoZero"/>
        <c:auto val="1"/>
        <c:lblAlgn val="ctr"/>
        <c:lblOffset val="100"/>
        <c:noMultiLvlLbl val="0"/>
      </c:catAx>
      <c:valAx>
        <c:axId val="5825691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  <a:latin typeface="Century" panose="02040604050505020304" pitchFamily="18" charset="0"/>
                  </a:rPr>
                  <a:t>log(Pre/Pos)</a:t>
                </a:r>
                <a:endParaRPr lang="ja-JP" altLang="en-US">
                  <a:solidFill>
                    <a:schemeClr val="tx1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Century" panose="0204060405050502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0_ 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5825652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Century" panose="020406040505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  <a:latin typeface="Century" panose="02040604050505020304" pitchFamily="18" charset="0"/>
              </a:rPr>
              <a:t>(a)</a:t>
            </a:r>
          </a:p>
        </c:rich>
      </c:tx>
      <c:layout>
        <c:manualLayout>
          <c:xMode val="edge"/>
          <c:yMode val="edge"/>
          <c:x val="2.6891316708272599E-2"/>
          <c:y val="2.288984607029105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FigS4!$B$1</c:f>
              <c:strCache>
                <c:ptCount val="1"/>
                <c:pt idx="0">
                  <c:v>tetA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3397398274452782"/>
                  <c:y val="0.38830431663170134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2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ja-JP" sz="1200" baseline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y = 1.1072x + 3.4779</a:t>
                    </a:r>
                    <a:br>
                      <a:rPr lang="en-US" altLang="ja-JP" sz="1200" baseline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</a:br>
                    <a:r>
                      <a:rPr lang="en-US" altLang="ja-JP" sz="1200" baseline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² = 0.5414</a:t>
                    </a:r>
                    <a:endParaRPr lang="en-US" altLang="ja-JP" sz="1200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FigS4!$A$2:$A$14</c:f>
              <c:numCache>
                <c:formatCode>General</c:formatCode>
                <c:ptCount val="13"/>
                <c:pt idx="0">
                  <c:v>2.9488474779999998</c:v>
                </c:pt>
                <c:pt idx="1">
                  <c:v>3.560667306</c:v>
                </c:pt>
                <c:pt idx="2">
                  <c:v>3.903089987</c:v>
                </c:pt>
                <c:pt idx="3">
                  <c:v>3.3849318799999999</c:v>
                </c:pt>
                <c:pt idx="4">
                  <c:v>2.0791812460000001</c:v>
                </c:pt>
                <c:pt idx="5">
                  <c:v>3.782516056</c:v>
                </c:pt>
                <c:pt idx="6">
                  <c:v>2.3225451380000002</c:v>
                </c:pt>
                <c:pt idx="7">
                  <c:v>3.0321846830000001</c:v>
                </c:pt>
                <c:pt idx="8">
                  <c:v>3.375663614</c:v>
                </c:pt>
                <c:pt idx="9">
                  <c:v>4.1747362050000003</c:v>
                </c:pt>
                <c:pt idx="10">
                  <c:v>2.2988639339999999</c:v>
                </c:pt>
                <c:pt idx="11">
                  <c:v>3.3098039199999998</c:v>
                </c:pt>
                <c:pt idx="12">
                  <c:v>2.8555987840000001</c:v>
                </c:pt>
              </c:numCache>
            </c:numRef>
          </c:xVal>
          <c:yVal>
            <c:numRef>
              <c:f>FigS4!$B$2:$B$14</c:f>
              <c:numCache>
                <c:formatCode>General</c:formatCode>
                <c:ptCount val="13"/>
                <c:pt idx="0">
                  <c:v>7.3493886000000002</c:v>
                </c:pt>
                <c:pt idx="1">
                  <c:v>7.5370166950000002</c:v>
                </c:pt>
                <c:pt idx="2">
                  <c:v>6.6159870139999999</c:v>
                </c:pt>
                <c:pt idx="3">
                  <c:v>6.0810857589999996</c:v>
                </c:pt>
                <c:pt idx="4">
                  <c:v>5.2718039179999998</c:v>
                </c:pt>
                <c:pt idx="5">
                  <c:v>8.0024056829999992</c:v>
                </c:pt>
                <c:pt idx="6">
                  <c:v>6.4739577769999999</c:v>
                </c:pt>
                <c:pt idx="7">
                  <c:v>7.6368559300000003</c:v>
                </c:pt>
                <c:pt idx="8">
                  <c:v>7.8388817499999996</c:v>
                </c:pt>
                <c:pt idx="9">
                  <c:v>8.3960256169999994</c:v>
                </c:pt>
                <c:pt idx="10">
                  <c:v>5.3946107559999996</c:v>
                </c:pt>
                <c:pt idx="11">
                  <c:v>7.1879540259999999</c:v>
                </c:pt>
                <c:pt idx="12">
                  <c:v>6.8543059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396-48E7-95B8-FAE0DFB56F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59515599"/>
        <c:axId val="1861426127"/>
      </c:scatterChart>
      <c:valAx>
        <c:axId val="1859515599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>
                    <a:solidFill>
                      <a:sysClr val="windowText" lastClr="000000"/>
                    </a:solidFill>
                    <a:latin typeface="Century" panose="02040604050505020304" pitchFamily="18" charset="0"/>
                  </a:rPr>
                  <a:t>OTC</a:t>
                </a:r>
              </a:p>
              <a:p>
                <a:pPr>
                  <a:defRPr/>
                </a:pPr>
                <a:r>
                  <a:rPr lang="en-US" altLang="ja-JP" sz="1050">
                    <a:solidFill>
                      <a:sysClr val="windowText" lastClr="000000"/>
                    </a:solidFill>
                    <a:latin typeface="Century" panose="02040604050505020304" pitchFamily="18" charset="0"/>
                  </a:rPr>
                  <a:t>log(ng/kg(w.w.))</a:t>
                </a:r>
                <a:endParaRPr lang="ja-JP" altLang="en-US">
                  <a:solidFill>
                    <a:sysClr val="windowText" lastClr="000000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0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1861426127"/>
        <c:crosses val="autoZero"/>
        <c:crossBetween val="midCat"/>
      </c:valAx>
      <c:valAx>
        <c:axId val="1861426127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i="1">
                    <a:solidFill>
                      <a:sysClr val="windowText" lastClr="000000"/>
                    </a:solidFill>
                    <a:latin typeface="Century" panose="02040604050505020304" pitchFamily="18" charset="0"/>
                  </a:rPr>
                  <a:t>tetA</a:t>
                </a:r>
              </a:p>
              <a:p>
                <a:pPr>
                  <a:defRPr/>
                </a:pPr>
                <a:r>
                  <a:rPr lang="en-US" altLang="ja-JP" sz="1050">
                    <a:solidFill>
                      <a:sysClr val="windowText" lastClr="000000"/>
                    </a:solidFill>
                    <a:latin typeface="Century" panose="02040604050505020304" pitchFamily="18" charset="0"/>
                  </a:rPr>
                  <a:t>log(copies/g(w.w.))</a:t>
                </a:r>
                <a:endParaRPr lang="ja-JP" altLang="en-US" sz="1050">
                  <a:solidFill>
                    <a:sysClr val="windowText" lastClr="000000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0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18595155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  <a:latin typeface="Century" panose="02040604050505020304" pitchFamily="18" charset="0"/>
              </a:rPr>
              <a:t>(b)</a:t>
            </a:r>
          </a:p>
        </c:rich>
      </c:tx>
      <c:layout>
        <c:manualLayout>
          <c:xMode val="edge"/>
          <c:yMode val="edge"/>
          <c:x val="2.6891316708272599E-2"/>
          <c:y val="2.288984607029105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FigS4!$C$1</c:f>
              <c:strCache>
                <c:ptCount val="1"/>
                <c:pt idx="0">
                  <c:v>tet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1582166300748301"/>
                  <c:y val="0.45985621362547074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FigS4!$A$2:$A$14</c:f>
              <c:numCache>
                <c:formatCode>General</c:formatCode>
                <c:ptCount val="13"/>
                <c:pt idx="0">
                  <c:v>2.9488474779999998</c:v>
                </c:pt>
                <c:pt idx="1">
                  <c:v>3.560667306</c:v>
                </c:pt>
                <c:pt idx="2">
                  <c:v>3.903089987</c:v>
                </c:pt>
                <c:pt idx="3">
                  <c:v>3.3849318799999999</c:v>
                </c:pt>
                <c:pt idx="4">
                  <c:v>2.0791812460000001</c:v>
                </c:pt>
                <c:pt idx="5">
                  <c:v>3.782516056</c:v>
                </c:pt>
                <c:pt idx="6">
                  <c:v>2.3225451380000002</c:v>
                </c:pt>
                <c:pt idx="7">
                  <c:v>3.0321846830000001</c:v>
                </c:pt>
                <c:pt idx="8">
                  <c:v>3.375663614</c:v>
                </c:pt>
                <c:pt idx="9">
                  <c:v>4.1747362050000003</c:v>
                </c:pt>
                <c:pt idx="10">
                  <c:v>2.2988639339999999</c:v>
                </c:pt>
                <c:pt idx="11">
                  <c:v>3.3098039199999998</c:v>
                </c:pt>
                <c:pt idx="12">
                  <c:v>2.8555987840000001</c:v>
                </c:pt>
              </c:numCache>
            </c:numRef>
          </c:xVal>
          <c:yVal>
            <c:numRef>
              <c:f>FigS4!$C$2:$C$14</c:f>
              <c:numCache>
                <c:formatCode>General</c:formatCode>
                <c:ptCount val="13"/>
                <c:pt idx="0">
                  <c:v>3.9298701440000001</c:v>
                </c:pt>
                <c:pt idx="1">
                  <c:v>7.6115587570000001</c:v>
                </c:pt>
                <c:pt idx="2">
                  <c:v>8.0627364260000007</c:v>
                </c:pt>
                <c:pt idx="3">
                  <c:v>3.4698696999999998</c:v>
                </c:pt>
                <c:pt idx="4">
                  <c:v>4.6475120160000003</c:v>
                </c:pt>
                <c:pt idx="5">
                  <c:v>8.5235754789999998</c:v>
                </c:pt>
                <c:pt idx="6">
                  <c:v>6.1350843990000001</c:v>
                </c:pt>
                <c:pt idx="7">
                  <c:v>2.9903540839999998</c:v>
                </c:pt>
                <c:pt idx="8">
                  <c:v>6.860572458</c:v>
                </c:pt>
                <c:pt idx="9">
                  <c:v>8.0475235430000005</c:v>
                </c:pt>
                <c:pt idx="10">
                  <c:v>4.4177494040000003</c:v>
                </c:pt>
                <c:pt idx="11">
                  <c:v>7.1377304400000003</c:v>
                </c:pt>
                <c:pt idx="12">
                  <c:v>5.563568693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B86-4F8A-9532-4F458ED30D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59515599"/>
        <c:axId val="1861426127"/>
      </c:scatterChart>
      <c:valAx>
        <c:axId val="1859515599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>
                    <a:solidFill>
                      <a:sysClr val="windowText" lastClr="000000"/>
                    </a:solidFill>
                    <a:latin typeface="Century" panose="02040604050505020304" pitchFamily="18" charset="0"/>
                  </a:rPr>
                  <a:t>OTC</a:t>
                </a:r>
              </a:p>
              <a:p>
                <a:pPr>
                  <a:defRPr/>
                </a:pPr>
                <a:r>
                  <a:rPr lang="en-US" altLang="ja-JP" sz="1050">
                    <a:solidFill>
                      <a:sysClr val="windowText" lastClr="000000"/>
                    </a:solidFill>
                    <a:latin typeface="Century" panose="02040604050505020304" pitchFamily="18" charset="0"/>
                  </a:rPr>
                  <a:t>log(ng/kg(w.w.))</a:t>
                </a:r>
                <a:endParaRPr lang="ja-JP" altLang="en-US">
                  <a:solidFill>
                    <a:sysClr val="windowText" lastClr="000000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0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1861426127"/>
        <c:crosses val="autoZero"/>
        <c:crossBetween val="midCat"/>
      </c:valAx>
      <c:valAx>
        <c:axId val="1861426127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i="1">
                    <a:solidFill>
                      <a:sysClr val="windowText" lastClr="000000"/>
                    </a:solidFill>
                    <a:latin typeface="Century" panose="02040604050505020304" pitchFamily="18" charset="0"/>
                  </a:rPr>
                  <a:t>tetB</a:t>
                </a:r>
              </a:p>
              <a:p>
                <a:pPr>
                  <a:defRPr/>
                </a:pPr>
                <a:r>
                  <a:rPr lang="en-US" altLang="ja-JP" sz="1050">
                    <a:solidFill>
                      <a:sysClr val="windowText" lastClr="000000"/>
                    </a:solidFill>
                    <a:latin typeface="Century" panose="02040604050505020304" pitchFamily="18" charset="0"/>
                  </a:rPr>
                  <a:t>log(copies/g(w.w.))</a:t>
                </a:r>
                <a:endParaRPr lang="ja-JP" altLang="en-US" sz="1050">
                  <a:solidFill>
                    <a:sysClr val="windowText" lastClr="000000"/>
                  </a:solidFill>
                  <a:latin typeface="Century" panose="020406040505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0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18595155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4887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8288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9077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6979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399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7573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347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403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4963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9910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131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FD002-31F2-4066-AE3A-AA19E90A07B0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CDAA1F-7B18-4CA2-92CE-7C14578C77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3988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DC295E1-CF30-4376-972F-6FF559F02CE8}"/>
              </a:ext>
            </a:extLst>
          </p:cNvPr>
          <p:cNvSpPr txBox="1"/>
          <p:nvPr/>
        </p:nvSpPr>
        <p:spPr>
          <a:xfrm>
            <a:off x="4918837" y="3486638"/>
            <a:ext cx="3962399" cy="28601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1.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tions in the abundance of total lactose-degrading Enterobacteriaceae tetracycline-resistant lactose-degrading Enterobacteriaceae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C-R), and cefazolin-resistant lactose-degrading Enterobacteriaceae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EZ-R) in the aerobic compost group (a;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5 for pre-treatment [Pre] and n=16 for post-treatment [Post]), liquid component in the anaerobic digestion group (b;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2 for both Pre and Post), and solid component in the anaerobic digestion group (c;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 and 6, for Pre and Post, respectively) following respective treatments across four seasons. Data are presented as the mean ratio of Pre abundance to Post abundance ± standard error of the mean.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CB76274C-1CAF-402B-8A70-8E8F6572D6C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5563731"/>
              </p:ext>
            </p:extLst>
          </p:nvPr>
        </p:nvGraphicFramePr>
        <p:xfrm>
          <a:off x="439983" y="439424"/>
          <a:ext cx="3898899" cy="26860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707B8993-5311-461D-8106-A3884B0F96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2976555"/>
              </p:ext>
            </p:extLst>
          </p:nvPr>
        </p:nvGraphicFramePr>
        <p:xfrm>
          <a:off x="4338882" y="439424"/>
          <a:ext cx="3898899" cy="26860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EFC64FBC-29EE-435C-A52E-E1E718F15B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42879510"/>
              </p:ext>
            </p:extLst>
          </p:nvPr>
        </p:nvGraphicFramePr>
        <p:xfrm>
          <a:off x="439983" y="3486638"/>
          <a:ext cx="3898899" cy="26860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4EAC4A5-616C-204C-BE6C-6519570DB766}"/>
              </a:ext>
            </a:extLst>
          </p:cNvPr>
          <p:cNvSpPr txBox="1"/>
          <p:nvPr/>
        </p:nvSpPr>
        <p:spPr>
          <a:xfrm>
            <a:off x="1350795" y="2572670"/>
            <a:ext cx="55175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endParaRPr kumimoji="1" lang="ja-JP" altLang="en-US" sz="11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33AEE05-BC22-8947-9486-19A98F4854C3}"/>
              </a:ext>
            </a:extLst>
          </p:cNvPr>
          <p:cNvSpPr txBox="1"/>
          <p:nvPr/>
        </p:nvSpPr>
        <p:spPr>
          <a:xfrm>
            <a:off x="5249694" y="2585496"/>
            <a:ext cx="55175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endParaRPr kumimoji="1" lang="ja-JP" altLang="en-US" sz="11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F0CCC06-4134-574D-9CF2-59617FE4D410}"/>
              </a:ext>
            </a:extLst>
          </p:cNvPr>
          <p:cNvSpPr txBox="1"/>
          <p:nvPr/>
        </p:nvSpPr>
        <p:spPr>
          <a:xfrm>
            <a:off x="1264596" y="5611604"/>
            <a:ext cx="55175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endParaRPr kumimoji="1" lang="ja-JP" altLang="en-US" sz="11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5591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CABED22-C057-442A-9584-DE69E96C4ACD}"/>
              </a:ext>
            </a:extLst>
          </p:cNvPr>
          <p:cNvSpPr txBox="1"/>
          <p:nvPr/>
        </p:nvSpPr>
        <p:spPr>
          <a:xfrm>
            <a:off x="5057449" y="4980230"/>
            <a:ext cx="374589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tions in the copy numbers of antimicrobial resistance genes (ARGs) in the aerobic compost group (a;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5 for both pre-treatment [Pre] and n=16 post-treatment [Post]), liquid component in the anaerobic digestion group (b;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2 for both Pre and Post), and solid component in the anaerobic digestion group (c;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 and 6, for Pre and Post, respectively) following respective treatments. Data are presented as the mean log ratio of Pre copy number to Post copy number ± standard error of the mean.</a:t>
            </a:r>
            <a:endParaRPr lang="ja-JP" altLang="ja-JP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 Box 129">
            <a:extLst>
              <a:ext uri="{FF2B5EF4-FFF2-40B4-BE49-F238E27FC236}">
                <a16:creationId xmlns:a16="http://schemas.microsoft.com/office/drawing/2014/main" id="{398125FB-6E5F-9C46-8C14-739B1E69634E}"/>
              </a:ext>
            </a:extLst>
          </p:cNvPr>
          <p:cNvSpPr txBox="1">
            <a:spLocks/>
          </p:cNvSpPr>
          <p:nvPr/>
        </p:nvSpPr>
        <p:spPr bwMode="auto">
          <a:xfrm>
            <a:off x="1080358" y="5905033"/>
            <a:ext cx="436130" cy="219072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tA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46" name="Text Box 130">
            <a:extLst>
              <a:ext uri="{FF2B5EF4-FFF2-40B4-BE49-F238E27FC236}">
                <a16:creationId xmlns:a16="http://schemas.microsoft.com/office/drawing/2014/main" id="{0EFC5C80-3D4B-0C4D-AD2A-DD65AAA05EC6}"/>
              </a:ext>
            </a:extLst>
          </p:cNvPr>
          <p:cNvSpPr txBox="1">
            <a:spLocks/>
          </p:cNvSpPr>
          <p:nvPr/>
        </p:nvSpPr>
        <p:spPr bwMode="auto">
          <a:xfrm>
            <a:off x="1664950" y="5905033"/>
            <a:ext cx="428420" cy="219073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tB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47" name="Text Box 131">
            <a:extLst>
              <a:ext uri="{FF2B5EF4-FFF2-40B4-BE49-F238E27FC236}">
                <a16:creationId xmlns:a16="http://schemas.microsoft.com/office/drawing/2014/main" id="{BB04A2BE-B9DE-8548-94DF-5F6EFAE99338}"/>
              </a:ext>
            </a:extLst>
          </p:cNvPr>
          <p:cNvSpPr txBox="1">
            <a:spLocks/>
          </p:cNvSpPr>
          <p:nvPr/>
        </p:nvSpPr>
        <p:spPr bwMode="auto">
          <a:xfrm>
            <a:off x="2213606" y="5907966"/>
            <a:ext cx="552450" cy="219072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M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48" name="Text Box 132">
            <a:extLst>
              <a:ext uri="{FF2B5EF4-FFF2-40B4-BE49-F238E27FC236}">
                <a16:creationId xmlns:a16="http://schemas.microsoft.com/office/drawing/2014/main" id="{854E2BD4-CD3E-C04F-8CEA-31C8579B3328}"/>
              </a:ext>
            </a:extLst>
          </p:cNvPr>
          <p:cNvSpPr txBox="1">
            <a:spLocks/>
          </p:cNvSpPr>
          <p:nvPr/>
        </p:nvSpPr>
        <p:spPr bwMode="auto">
          <a:xfrm>
            <a:off x="2806648" y="5905033"/>
            <a:ext cx="552450" cy="219073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SHV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49" name="Text Box 133">
            <a:extLst>
              <a:ext uri="{FF2B5EF4-FFF2-40B4-BE49-F238E27FC236}">
                <a16:creationId xmlns:a16="http://schemas.microsoft.com/office/drawing/2014/main" id="{203044A6-7668-C64C-BC21-7322BFFE861D}"/>
              </a:ext>
            </a:extLst>
          </p:cNvPr>
          <p:cNvSpPr txBox="1">
            <a:spLocks/>
          </p:cNvSpPr>
          <p:nvPr/>
        </p:nvSpPr>
        <p:spPr bwMode="auto">
          <a:xfrm>
            <a:off x="3466051" y="5907987"/>
            <a:ext cx="572400" cy="219070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CTX</a:t>
            </a:r>
            <a:r>
              <a:rPr lang="en-US" sz="900" kern="100" baseline="-250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-M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50" name="Text Box 129">
            <a:extLst>
              <a:ext uri="{FF2B5EF4-FFF2-40B4-BE49-F238E27FC236}">
                <a16:creationId xmlns:a16="http://schemas.microsoft.com/office/drawing/2014/main" id="{E811095B-3D8E-E24E-8FF8-B79CA0A97A61}"/>
              </a:ext>
            </a:extLst>
          </p:cNvPr>
          <p:cNvSpPr txBox="1">
            <a:spLocks/>
          </p:cNvSpPr>
          <p:nvPr/>
        </p:nvSpPr>
        <p:spPr bwMode="auto">
          <a:xfrm>
            <a:off x="4005300" y="5905033"/>
            <a:ext cx="710319" cy="219072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10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16S rRNA gene</a:t>
            </a:r>
            <a:endParaRPr 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65E4BC32-E3E1-4BB1-BC74-943339C00A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784514"/>
              </p:ext>
            </p:extLst>
          </p:nvPr>
        </p:nvGraphicFramePr>
        <p:xfrm>
          <a:off x="120512" y="447205"/>
          <a:ext cx="4483100" cy="2838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378351E3-91B2-4595-AC53-63FE3BEDCC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5447622"/>
              </p:ext>
            </p:extLst>
          </p:nvPr>
        </p:nvGraphicFramePr>
        <p:xfrm>
          <a:off x="4385264" y="383088"/>
          <a:ext cx="4483100" cy="2838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AD460BEB-D55F-40D9-B9E9-DA7C7CC4DB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8740965"/>
              </p:ext>
            </p:extLst>
          </p:nvPr>
        </p:nvGraphicFramePr>
        <p:xfrm>
          <a:off x="182121" y="3561005"/>
          <a:ext cx="4483100" cy="2838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7" name="Text Box 129">
            <a:extLst>
              <a:ext uri="{FF2B5EF4-FFF2-40B4-BE49-F238E27FC236}">
                <a16:creationId xmlns:a16="http://schemas.microsoft.com/office/drawing/2014/main" id="{0353D815-D83E-4A45-ADF5-0CC856D59A79}"/>
              </a:ext>
            </a:extLst>
          </p:cNvPr>
          <p:cNvSpPr txBox="1">
            <a:spLocks/>
          </p:cNvSpPr>
          <p:nvPr/>
        </p:nvSpPr>
        <p:spPr bwMode="auto">
          <a:xfrm>
            <a:off x="1106024" y="2723009"/>
            <a:ext cx="436130" cy="219072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tA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28" name="Text Box 130">
            <a:extLst>
              <a:ext uri="{FF2B5EF4-FFF2-40B4-BE49-F238E27FC236}">
                <a16:creationId xmlns:a16="http://schemas.microsoft.com/office/drawing/2014/main" id="{D99CECA7-E0E1-3846-B3F9-C1C80BE7B8DE}"/>
              </a:ext>
            </a:extLst>
          </p:cNvPr>
          <p:cNvSpPr txBox="1">
            <a:spLocks/>
          </p:cNvSpPr>
          <p:nvPr/>
        </p:nvSpPr>
        <p:spPr bwMode="auto">
          <a:xfrm>
            <a:off x="1747549" y="2723009"/>
            <a:ext cx="428420" cy="219073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tB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29" name="Text Box 131">
            <a:extLst>
              <a:ext uri="{FF2B5EF4-FFF2-40B4-BE49-F238E27FC236}">
                <a16:creationId xmlns:a16="http://schemas.microsoft.com/office/drawing/2014/main" id="{60E77634-3AD7-1648-8023-4B46EB8B1010}"/>
              </a:ext>
            </a:extLst>
          </p:cNvPr>
          <p:cNvSpPr txBox="1">
            <a:spLocks/>
          </p:cNvSpPr>
          <p:nvPr/>
        </p:nvSpPr>
        <p:spPr bwMode="auto">
          <a:xfrm>
            <a:off x="2324685" y="2723009"/>
            <a:ext cx="552450" cy="219072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M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51" name="Text Box 132">
            <a:extLst>
              <a:ext uri="{FF2B5EF4-FFF2-40B4-BE49-F238E27FC236}">
                <a16:creationId xmlns:a16="http://schemas.microsoft.com/office/drawing/2014/main" id="{79E1FC51-BB27-5649-A574-77A8176BC625}"/>
              </a:ext>
            </a:extLst>
          </p:cNvPr>
          <p:cNvSpPr txBox="1">
            <a:spLocks/>
          </p:cNvSpPr>
          <p:nvPr/>
        </p:nvSpPr>
        <p:spPr bwMode="auto">
          <a:xfrm>
            <a:off x="3046207" y="2723009"/>
            <a:ext cx="552450" cy="219073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SHV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52" name="Text Box 133">
            <a:extLst>
              <a:ext uri="{FF2B5EF4-FFF2-40B4-BE49-F238E27FC236}">
                <a16:creationId xmlns:a16="http://schemas.microsoft.com/office/drawing/2014/main" id="{8A6AD108-19D8-514D-8285-33241DB1B740}"/>
              </a:ext>
            </a:extLst>
          </p:cNvPr>
          <p:cNvSpPr txBox="1">
            <a:spLocks/>
          </p:cNvSpPr>
          <p:nvPr/>
        </p:nvSpPr>
        <p:spPr bwMode="auto">
          <a:xfrm>
            <a:off x="3788059" y="2723011"/>
            <a:ext cx="572400" cy="219070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CTX</a:t>
            </a:r>
            <a:r>
              <a:rPr lang="en-US" sz="900" kern="100" baseline="-250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-M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0" name="Text Box 129">
            <a:extLst>
              <a:ext uri="{FF2B5EF4-FFF2-40B4-BE49-F238E27FC236}">
                <a16:creationId xmlns:a16="http://schemas.microsoft.com/office/drawing/2014/main" id="{8D7D5376-41AE-A745-9B8C-1E537CF5EF0F}"/>
              </a:ext>
            </a:extLst>
          </p:cNvPr>
          <p:cNvSpPr txBox="1">
            <a:spLocks/>
          </p:cNvSpPr>
          <p:nvPr/>
        </p:nvSpPr>
        <p:spPr bwMode="auto">
          <a:xfrm>
            <a:off x="5302226" y="2708224"/>
            <a:ext cx="436130" cy="219072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tA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1" name="Text Box 130">
            <a:extLst>
              <a:ext uri="{FF2B5EF4-FFF2-40B4-BE49-F238E27FC236}">
                <a16:creationId xmlns:a16="http://schemas.microsoft.com/office/drawing/2014/main" id="{8512BC54-5A44-B440-B6E6-AAA9D96F4696}"/>
              </a:ext>
            </a:extLst>
          </p:cNvPr>
          <p:cNvSpPr txBox="1">
            <a:spLocks/>
          </p:cNvSpPr>
          <p:nvPr/>
        </p:nvSpPr>
        <p:spPr bwMode="auto">
          <a:xfrm>
            <a:off x="5943751" y="2708224"/>
            <a:ext cx="428420" cy="219073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tB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2" name="Text Box 131">
            <a:extLst>
              <a:ext uri="{FF2B5EF4-FFF2-40B4-BE49-F238E27FC236}">
                <a16:creationId xmlns:a16="http://schemas.microsoft.com/office/drawing/2014/main" id="{17804DFB-5642-D540-8265-0C0F4077B657}"/>
              </a:ext>
            </a:extLst>
          </p:cNvPr>
          <p:cNvSpPr txBox="1">
            <a:spLocks/>
          </p:cNvSpPr>
          <p:nvPr/>
        </p:nvSpPr>
        <p:spPr bwMode="auto">
          <a:xfrm>
            <a:off x="6520887" y="2708224"/>
            <a:ext cx="552450" cy="219072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M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3" name="Text Box 132">
            <a:extLst>
              <a:ext uri="{FF2B5EF4-FFF2-40B4-BE49-F238E27FC236}">
                <a16:creationId xmlns:a16="http://schemas.microsoft.com/office/drawing/2014/main" id="{275076B3-A1F8-ED4C-8C89-F3C39E2A9B0C}"/>
              </a:ext>
            </a:extLst>
          </p:cNvPr>
          <p:cNvSpPr txBox="1">
            <a:spLocks/>
          </p:cNvSpPr>
          <p:nvPr/>
        </p:nvSpPr>
        <p:spPr bwMode="auto">
          <a:xfrm>
            <a:off x="7242409" y="2708224"/>
            <a:ext cx="552450" cy="219073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SHV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4" name="Text Box 133">
            <a:extLst>
              <a:ext uri="{FF2B5EF4-FFF2-40B4-BE49-F238E27FC236}">
                <a16:creationId xmlns:a16="http://schemas.microsoft.com/office/drawing/2014/main" id="{FF2C2BBD-F5E8-7940-BF79-29F27F5F7129}"/>
              </a:ext>
            </a:extLst>
          </p:cNvPr>
          <p:cNvSpPr txBox="1">
            <a:spLocks/>
          </p:cNvSpPr>
          <p:nvPr/>
        </p:nvSpPr>
        <p:spPr bwMode="auto">
          <a:xfrm>
            <a:off x="8009066" y="2722273"/>
            <a:ext cx="572400" cy="219070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CTX</a:t>
            </a:r>
            <a:r>
              <a:rPr lang="en-US" sz="900" kern="100" baseline="-250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-M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5" name="Text Box 129">
            <a:extLst>
              <a:ext uri="{FF2B5EF4-FFF2-40B4-BE49-F238E27FC236}">
                <a16:creationId xmlns:a16="http://schemas.microsoft.com/office/drawing/2014/main" id="{8B9BA02C-4AC9-8548-AA32-20FF5DDB54B6}"/>
              </a:ext>
            </a:extLst>
          </p:cNvPr>
          <p:cNvSpPr txBox="1">
            <a:spLocks/>
          </p:cNvSpPr>
          <p:nvPr/>
        </p:nvSpPr>
        <p:spPr bwMode="auto">
          <a:xfrm>
            <a:off x="1106024" y="5859614"/>
            <a:ext cx="436130" cy="219072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tA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6" name="Text Box 130">
            <a:extLst>
              <a:ext uri="{FF2B5EF4-FFF2-40B4-BE49-F238E27FC236}">
                <a16:creationId xmlns:a16="http://schemas.microsoft.com/office/drawing/2014/main" id="{6B10F240-FCF8-3148-B2F0-64D63ACCF35A}"/>
              </a:ext>
            </a:extLst>
          </p:cNvPr>
          <p:cNvSpPr txBox="1">
            <a:spLocks/>
          </p:cNvSpPr>
          <p:nvPr/>
        </p:nvSpPr>
        <p:spPr bwMode="auto">
          <a:xfrm>
            <a:off x="1747549" y="5859614"/>
            <a:ext cx="428420" cy="219073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tB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7" name="Text Box 131">
            <a:extLst>
              <a:ext uri="{FF2B5EF4-FFF2-40B4-BE49-F238E27FC236}">
                <a16:creationId xmlns:a16="http://schemas.microsoft.com/office/drawing/2014/main" id="{9BF167D3-D4AD-2740-ADDC-08A23E32BA7E}"/>
              </a:ext>
            </a:extLst>
          </p:cNvPr>
          <p:cNvSpPr txBox="1">
            <a:spLocks/>
          </p:cNvSpPr>
          <p:nvPr/>
        </p:nvSpPr>
        <p:spPr bwMode="auto">
          <a:xfrm>
            <a:off x="2324685" y="5859614"/>
            <a:ext cx="552450" cy="219072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TEM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8" name="Text Box 132">
            <a:extLst>
              <a:ext uri="{FF2B5EF4-FFF2-40B4-BE49-F238E27FC236}">
                <a16:creationId xmlns:a16="http://schemas.microsoft.com/office/drawing/2014/main" id="{2CFBE782-D3AA-B94C-9B12-1ECD760FBA4B}"/>
              </a:ext>
            </a:extLst>
          </p:cNvPr>
          <p:cNvSpPr txBox="1">
            <a:spLocks/>
          </p:cNvSpPr>
          <p:nvPr/>
        </p:nvSpPr>
        <p:spPr bwMode="auto">
          <a:xfrm>
            <a:off x="3046207" y="5859614"/>
            <a:ext cx="552450" cy="219073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SHV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69" name="Text Box 133">
            <a:extLst>
              <a:ext uri="{FF2B5EF4-FFF2-40B4-BE49-F238E27FC236}">
                <a16:creationId xmlns:a16="http://schemas.microsoft.com/office/drawing/2014/main" id="{C78FFAA8-F351-274F-9A68-A0D7DD7C537F}"/>
              </a:ext>
            </a:extLst>
          </p:cNvPr>
          <p:cNvSpPr txBox="1">
            <a:spLocks/>
          </p:cNvSpPr>
          <p:nvPr/>
        </p:nvSpPr>
        <p:spPr bwMode="auto">
          <a:xfrm>
            <a:off x="3788059" y="5859616"/>
            <a:ext cx="572400" cy="219070"/>
          </a:xfrm>
          <a:prstGeom prst="rect">
            <a:avLst/>
          </a:prstGeom>
          <a:solidFill>
            <a:schemeClr val="bg1">
              <a:lumMod val="100000"/>
              <a:lumOff val="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74295" tIns="8890" rIns="74295" bIns="889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900" i="1" kern="1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bla</a:t>
            </a:r>
            <a:r>
              <a:rPr lang="en-US" sz="900" kern="100" baseline="-25000" dirty="0" err="1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CTX</a:t>
            </a:r>
            <a:r>
              <a:rPr lang="en-US" sz="900" kern="100" baseline="-250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-M</a:t>
            </a:r>
            <a:endParaRPr 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95129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968126E-4AF2-4F27-8008-B25E7C87C14B}"/>
              </a:ext>
            </a:extLst>
          </p:cNvPr>
          <p:cNvSpPr txBox="1"/>
          <p:nvPr/>
        </p:nvSpPr>
        <p:spPr>
          <a:xfrm>
            <a:off x="355276" y="4508294"/>
            <a:ext cx="850362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s between absolute levels of oxytetracycline (OTC) and copy numbers of </a:t>
            </a:r>
            <a:r>
              <a:rPr lang="en-US" altLang="ja-JP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tA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nd </a:t>
            </a:r>
            <a:r>
              <a:rPr lang="en-US" altLang="ja-JP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tB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in the aerobic compost samples in which residual OTC was detectable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3).</a:t>
            </a:r>
            <a:endParaRPr lang="ja-JP" altLang="ja-JP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5E8C98AB-F92C-47D5-8188-30D08A5284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7577355"/>
              </p:ext>
            </p:extLst>
          </p:nvPr>
        </p:nvGraphicFramePr>
        <p:xfrm>
          <a:off x="355277" y="457200"/>
          <a:ext cx="4216724" cy="39837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8147D848-B8DA-4E4F-9A94-4A5144FB2D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0489679"/>
              </p:ext>
            </p:extLst>
          </p:nvPr>
        </p:nvGraphicFramePr>
        <p:xfrm>
          <a:off x="4572000" y="529390"/>
          <a:ext cx="4286900" cy="39115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197794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7</TotalTime>
  <Words>406</Words>
  <Application>Microsoft Macintosh PowerPoint</Application>
  <PresentationFormat>画面に合わせる (4:3)</PresentationFormat>
  <Paragraphs>4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片田 理志</dc:creator>
  <cp:lastModifiedBy>Microsoft Office User</cp:lastModifiedBy>
  <cp:revision>33</cp:revision>
  <dcterms:created xsi:type="dcterms:W3CDTF">2020-11-21T12:49:43Z</dcterms:created>
  <dcterms:modified xsi:type="dcterms:W3CDTF">2021-08-28T02:26:05Z</dcterms:modified>
</cp:coreProperties>
</file>